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8C5070-FF2C-4AB2-A98A-099F0EC384A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E2A8D7-188C-46CD-8A9C-33732E5062A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27AE61-64A1-44A3-9745-28A3D1012B0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6D46BB-1A46-4FA6-B596-9EA17E417CE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93523E-B0A7-4B38-B0EB-168070BCDF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B75EE4-3688-45D5-A0D9-AAC0F0F17D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DE1D12-D636-4051-B366-447E73BC7E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A857F8-2220-43B8-8023-3FAAC2E23E9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17448E-7EB5-4310-8A6C-D2A3F5BE05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7B09F2-8934-4368-9C56-BD47AE6BBB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7E32E1-4F76-4E97-99C2-0B41245869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EBB052-11A5-48A1-963E-E8D744DF9D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l-P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l-P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EEC02E9-9984-40DE-86C3-84A5AF0B090F}" type="slidenum">
              <a:rPr b="0" lang="pl-PL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a 32"/>
          <p:cNvGrpSpPr/>
          <p:nvPr/>
        </p:nvGrpSpPr>
        <p:grpSpPr>
          <a:xfrm>
            <a:off x="260280" y="34920"/>
            <a:ext cx="6913800" cy="9081360"/>
            <a:chOff x="260280" y="34920"/>
            <a:chExt cx="6913800" cy="9081360"/>
          </a:xfrm>
        </p:grpSpPr>
        <p:sp>
          <p:nvSpPr>
            <p:cNvPr id="42" name="TextBox 11"/>
            <p:cNvSpPr/>
            <p:nvPr/>
          </p:nvSpPr>
          <p:spPr>
            <a:xfrm>
              <a:off x="4149360" y="8748000"/>
              <a:ext cx="30247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             </a:t>
              </a:r>
              <a:r>
                <a:rPr b="1" lang="en-US" sz="14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Supplementary Figure 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3" name="Grupa 31"/>
            <p:cNvGrpSpPr/>
            <p:nvPr/>
          </p:nvGrpSpPr>
          <p:grpSpPr>
            <a:xfrm>
              <a:off x="260280" y="4427280"/>
              <a:ext cx="6409080" cy="4319640"/>
              <a:chOff x="260280" y="4427280"/>
              <a:chExt cx="6409080" cy="4319640"/>
            </a:xfrm>
          </p:grpSpPr>
          <p:grpSp>
            <p:nvGrpSpPr>
              <p:cNvPr id="44" name="Grupa 10"/>
              <p:cNvGrpSpPr/>
              <p:nvPr/>
            </p:nvGrpSpPr>
            <p:grpSpPr>
              <a:xfrm>
                <a:off x="495720" y="4695480"/>
                <a:ext cx="5742360" cy="3979800"/>
                <a:chOff x="495720" y="4695480"/>
                <a:chExt cx="5742360" cy="3979800"/>
              </a:xfrm>
            </p:grpSpPr>
            <p:pic>
              <p:nvPicPr>
                <p:cNvPr id="45" name="Wykres 4" descr="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731160" y="4695480"/>
                  <a:ext cx="5506920" cy="36684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46" name="pole tekstowe 8"/>
                <p:cNvSpPr/>
                <p:nvPr/>
              </p:nvSpPr>
              <p:spPr>
                <a:xfrm rot="16200000">
                  <a:off x="-281880" y="6194520"/>
                  <a:ext cx="186300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Calibri"/>
                      <a:ea typeface="Times New Roman"/>
                    </a:rPr>
                    <a:t>A</a:t>
                  </a:r>
                  <a:r>
                    <a:rPr b="0" lang="pl-PL" sz="1400" spc="-1" strike="noStrike">
                      <a:solidFill>
                        <a:srgbClr val="000000"/>
                      </a:solidFill>
                      <a:latin typeface="Calibri"/>
                      <a:ea typeface="Times New Roman"/>
                    </a:rPr>
                    <a:t>average weight [g]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" name="pole tekstowe 9"/>
                <p:cNvSpPr/>
                <p:nvPr/>
              </p:nvSpPr>
              <p:spPr>
                <a:xfrm>
                  <a:off x="2172240" y="8368200"/>
                  <a:ext cx="237744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Calibri"/>
                      <a:ea typeface="Times New Roman"/>
                    </a:rPr>
                    <a:t>T</a:t>
                  </a:r>
                  <a:r>
                    <a:rPr b="0" lang="pl-PL" sz="1400" spc="-1" strike="noStrike">
                      <a:solidFill>
                        <a:srgbClr val="000000"/>
                      </a:solidFill>
                      <a:latin typeface="Calibri"/>
                      <a:ea typeface="Times New Roman"/>
                    </a:rPr>
                    <a:t>ime of experiment [week</a:t>
                  </a:r>
                  <a:r>
                    <a:rPr b="0" lang="en-US" sz="1400" spc="-1" strike="noStrike">
                      <a:solidFill>
                        <a:srgbClr val="000000"/>
                      </a:solidFill>
                      <a:latin typeface="Calibri"/>
                      <a:ea typeface="Times New Roman"/>
                    </a:rPr>
                    <a:t>s</a:t>
                  </a:r>
                  <a:r>
                    <a:rPr b="0" lang="pl-PL" sz="1400" spc="-1" strike="noStrike">
                      <a:solidFill>
                        <a:srgbClr val="000000"/>
                      </a:solidFill>
                      <a:latin typeface="Calibri"/>
                      <a:ea typeface="Times New Roman"/>
                    </a:rPr>
                    <a:t>]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48" name="Prostokąt 11"/>
              <p:cNvSpPr/>
              <p:nvPr/>
            </p:nvSpPr>
            <p:spPr>
              <a:xfrm>
                <a:off x="260280" y="4427280"/>
                <a:ext cx="6409080" cy="431964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pole tekstowe 12"/>
              <p:cNvSpPr/>
              <p:nvPr/>
            </p:nvSpPr>
            <p:spPr>
              <a:xfrm>
                <a:off x="332280" y="4427280"/>
                <a:ext cx="43200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l-PL" sz="2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B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Prostokąt 19"/>
              <p:cNvSpPr/>
              <p:nvPr/>
            </p:nvSpPr>
            <p:spPr>
              <a:xfrm>
                <a:off x="6021720" y="6298920"/>
                <a:ext cx="215640" cy="4316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1" name="Grupa 23"/>
              <p:cNvGrpSpPr/>
              <p:nvPr/>
            </p:nvGrpSpPr>
            <p:grpSpPr>
              <a:xfrm>
                <a:off x="6022080" y="6279480"/>
                <a:ext cx="622080" cy="507960"/>
                <a:chOff x="6022080" y="6279480"/>
                <a:chExt cx="622080" cy="507960"/>
              </a:xfrm>
            </p:grpSpPr>
            <p:sp>
              <p:nvSpPr>
                <p:cNvPr id="52" name="pole tekstowe 24"/>
                <p:cNvSpPr/>
                <p:nvPr/>
              </p:nvSpPr>
              <p:spPr>
                <a:xfrm>
                  <a:off x="6022080" y="6526080"/>
                  <a:ext cx="6220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pl-PL" sz="1100" spc="-1" strike="noStrike">
                      <a:solidFill>
                        <a:srgbClr val="000000"/>
                      </a:solidFill>
                      <a:latin typeface="Calibri"/>
                      <a:ea typeface="Arial"/>
                    </a:rPr>
                    <a:t>Control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" name="pole tekstowe 25"/>
                <p:cNvSpPr/>
                <p:nvPr/>
              </p:nvSpPr>
              <p:spPr>
                <a:xfrm>
                  <a:off x="6022080" y="6279480"/>
                  <a:ext cx="43236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pl-PL" sz="1100" spc="-1" strike="noStrike">
                      <a:solidFill>
                        <a:srgbClr val="000000"/>
                      </a:solidFill>
                      <a:latin typeface="Calibri"/>
                      <a:ea typeface="Arial"/>
                    </a:rPr>
                    <a:t>CR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54" name="Grupa 30"/>
            <p:cNvGrpSpPr/>
            <p:nvPr/>
          </p:nvGrpSpPr>
          <p:grpSpPr>
            <a:xfrm>
              <a:off x="260280" y="34920"/>
              <a:ext cx="6409080" cy="4319640"/>
              <a:chOff x="260280" y="34920"/>
              <a:chExt cx="6409080" cy="4319640"/>
            </a:xfrm>
          </p:grpSpPr>
          <p:pic>
            <p:nvPicPr>
              <p:cNvPr id="55" name="Wykres 13" descr=""/>
              <p:cNvPicPr/>
              <p:nvPr/>
            </p:nvPicPr>
            <p:blipFill>
              <a:blip r:embed="rId2"/>
              <a:stretch/>
            </p:blipFill>
            <p:spPr>
              <a:xfrm>
                <a:off x="688680" y="389880"/>
                <a:ext cx="5584320" cy="36698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6" name="Prostokąt 14"/>
              <p:cNvSpPr/>
              <p:nvPr/>
            </p:nvSpPr>
            <p:spPr>
              <a:xfrm>
                <a:off x="260280" y="34920"/>
                <a:ext cx="6409080" cy="431964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pole tekstowe 15"/>
              <p:cNvSpPr/>
              <p:nvPr/>
            </p:nvSpPr>
            <p:spPr>
              <a:xfrm>
                <a:off x="332280" y="34920"/>
                <a:ext cx="43200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l-PL" sz="2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A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pole tekstowe 16"/>
              <p:cNvSpPr/>
              <p:nvPr/>
            </p:nvSpPr>
            <p:spPr>
              <a:xfrm rot="16200000">
                <a:off x="-301680" y="1892880"/>
                <a:ext cx="1863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  <a:ea typeface="Times New Roman"/>
                  </a:rPr>
                  <a:t>A</a:t>
                </a:r>
                <a:r>
                  <a:rPr b="0" lang="pl-PL" sz="1400" spc="-1" strike="noStrike">
                    <a:solidFill>
                      <a:srgbClr val="000000"/>
                    </a:solidFill>
                    <a:latin typeface="Calibri"/>
                    <a:ea typeface="Times New Roman"/>
                  </a:rPr>
                  <a:t>average weight [g]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pole tekstowe 17"/>
              <p:cNvSpPr/>
              <p:nvPr/>
            </p:nvSpPr>
            <p:spPr>
              <a:xfrm>
                <a:off x="2204640" y="3995640"/>
                <a:ext cx="2376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  <a:ea typeface="Times New Roman"/>
                  </a:rPr>
                  <a:t>T</a:t>
                </a:r>
                <a:r>
                  <a:rPr b="0" lang="pl-PL" sz="1400" spc="-1" strike="noStrike">
                    <a:solidFill>
                      <a:srgbClr val="000000"/>
                    </a:solidFill>
                    <a:latin typeface="Calibri"/>
                    <a:ea typeface="Times New Roman"/>
                  </a:rPr>
                  <a:t>ime of experiment [week</a:t>
                </a: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  <a:ea typeface="Times New Roman"/>
                  </a:rPr>
                  <a:t>s</a:t>
                </a:r>
                <a:r>
                  <a:rPr b="0" lang="pl-PL" sz="1400" spc="-1" strike="noStrike">
                    <a:solidFill>
                      <a:srgbClr val="000000"/>
                    </a:solidFill>
                    <a:latin typeface="Calibri"/>
                    <a:ea typeface="Times New Roman"/>
                  </a:rPr>
                  <a:t>]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Prostokąt 18"/>
              <p:cNvSpPr/>
              <p:nvPr/>
            </p:nvSpPr>
            <p:spPr>
              <a:xfrm>
                <a:off x="6021720" y="2050920"/>
                <a:ext cx="215640" cy="4316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61" name="Grupa 22"/>
              <p:cNvGrpSpPr/>
              <p:nvPr/>
            </p:nvGrpSpPr>
            <p:grpSpPr>
              <a:xfrm>
                <a:off x="6022080" y="1959480"/>
                <a:ext cx="622080" cy="507960"/>
                <a:chOff x="6022080" y="1959480"/>
                <a:chExt cx="622080" cy="507960"/>
              </a:xfrm>
            </p:grpSpPr>
            <p:sp>
              <p:nvSpPr>
                <p:cNvPr id="62" name="pole tekstowe 20"/>
                <p:cNvSpPr/>
                <p:nvPr/>
              </p:nvSpPr>
              <p:spPr>
                <a:xfrm>
                  <a:off x="6022080" y="2206080"/>
                  <a:ext cx="6220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pl-PL" sz="1100" spc="-1" strike="noStrike">
                      <a:solidFill>
                        <a:srgbClr val="000000"/>
                      </a:solidFill>
                      <a:latin typeface="Calibri"/>
                      <a:ea typeface="Arial"/>
                    </a:rPr>
                    <a:t>Control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" name="pole tekstowe 21"/>
                <p:cNvSpPr/>
                <p:nvPr/>
              </p:nvSpPr>
              <p:spPr>
                <a:xfrm>
                  <a:off x="6022080" y="1959480"/>
                  <a:ext cx="43236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pl-PL" sz="1100" spc="-1" strike="noStrike">
                      <a:solidFill>
                        <a:srgbClr val="000000"/>
                      </a:solidFill>
                      <a:latin typeface="Calibri"/>
                      <a:ea typeface="Arial"/>
                    </a:rPr>
                    <a:t>CR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4" name="pole tekstowe 27"/>
              <p:cNvSpPr/>
              <p:nvPr/>
            </p:nvSpPr>
            <p:spPr>
              <a:xfrm>
                <a:off x="5878080" y="322920"/>
                <a:ext cx="5760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l-PL" sz="18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*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pole tekstowe 29"/>
              <p:cNvSpPr/>
              <p:nvPr/>
            </p:nvSpPr>
            <p:spPr>
              <a:xfrm>
                <a:off x="5510880" y="3999960"/>
                <a:ext cx="1071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pl-PL" sz="1400" spc="-1" strike="noStrike">
                    <a:solidFill>
                      <a:srgbClr val="000000"/>
                    </a:solidFill>
                    <a:latin typeface="Calibri"/>
                    <a:ea typeface="Arial"/>
                  </a:rPr>
                  <a:t>*p&lt;0,05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5-29T19:36:03Z</dcterms:created>
  <dc:creator>PAM</dc:creator>
  <dc:description/>
  <dc:language>en-US</dc:language>
  <cp:lastModifiedBy>Ratajczak,Mariusz</cp:lastModifiedBy>
  <dcterms:modified xsi:type="dcterms:W3CDTF">2014-05-30T13:33:41Z</dcterms:modified>
  <cp:revision>9</cp:revision>
  <dc:subject/>
  <dc:title>Slajd 1</dc:title>
</cp:coreProperties>
</file>